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  <p:sldId id="261" r:id="rId5"/>
    <p:sldId id="260" r:id="rId6"/>
    <p:sldId id="259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wmf"/><Relationship Id="rId2" Type="http://schemas.openxmlformats.org/officeDocument/2006/relationships/image" Target="../media/image5.wmf"/><Relationship Id="rId1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BB5B73-C43C-47B8-9EEC-DD6EC08832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69BAF52-53AA-4CE1-A934-9B57A0470B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96E3D5-62D6-4B53-ABA2-B079C34A8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4D3ECA-54D2-40C3-978A-2AA563D0D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335B8B-96FF-49FC-AE4D-3932468A1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636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A634A6-843A-40D4-889E-29EC545B2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8F55D2-71CE-4C5D-801A-E4750838C0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492D30-B27F-401D-ABD9-8BD3066CC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4F3780-D71C-4BCE-9307-AD1E57D1B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87B1FF-4B1C-4737-A563-DAFD9BC54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2583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173B8B-7C2F-465B-94F5-EC638456FA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EB57D4-4AFE-4B70-8D20-DB84EBCE4E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48B534-DCF2-4AB1-9CDF-5A2FF9B300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D22776-CFF0-4EAD-8ADB-DDC1AE26D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5F2861-FCEF-49E9-AAB2-38BD0C9FA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538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464ED-6FE3-49BF-968F-B578E2D78F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2FE07A-9211-46B4-82E2-AFAB38A6F1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9085CA-9F70-4123-A2D3-5F94D5FD9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DF0B0D-B1B4-4B45-8CAA-F4227EBAB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9EFC88-3B8C-4AA3-A555-4EB1A54DB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989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E7E21-2553-476D-A8D2-D8F1A944D1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F05068-1E48-484D-8739-F3B0B59136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8F0551-59A8-460B-B30C-BA63E61B9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FD732D-890D-41C3-A86B-A7B7C05956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B6704E-BA81-47DF-B7C1-AFF971D12B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447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5AA034-3B91-4EB1-A568-D52C4C476B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2EC74E-8E4F-45E7-9E79-E030D021A1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E109DC-3360-452E-896A-161C15301D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99FECA-794E-44A9-A486-7652B71F1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EA6FFD-D5CE-4A46-8BBC-17763B0CE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FBBB09-5FCD-490F-853E-D13E5F744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156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E90AC3-07B7-4B19-BDF9-2A0F700EDC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BF9B94-57AB-4A4C-BD11-9B8086184B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F365B63-8AAA-4192-9FC6-B5D3C06CE4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411E39D-B11C-4AD3-92E3-35A130B0F1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6A6A60F-16DF-49BB-AD9E-20242B4779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7FE106-46B8-4E09-8196-010B13B5D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ADC84EF-9673-4989-911C-0EE523915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20621A5-FE86-4FC1-BBF7-C2EFF030C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068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634FFB-A861-4D35-AEEC-8D8846D442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22E809-5323-4F42-82E1-9C213744C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C12614D-9D6F-4169-9F76-5B7A1D459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681B4B-C9FD-40F0-91A1-39EE4403A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620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45AED5-2691-493C-8CB9-4F25F3BCB6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C6053DD-A895-43F6-ACA2-FBB479C3E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0B1347-D450-40AA-9F2C-35453554BE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3884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877AD0-CFB5-4522-A1CA-C55016CE4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FB9DBA-3D19-4102-B658-449BCA7C8ED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9D4A7C-E7E3-45C5-A299-86FD1C3AB8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AC3CBB-3923-407F-9FB4-AA55BDF8B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9AB0E3-4BC5-4AE1-A517-2769FCED7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028737-6307-4734-A78C-8DE716E8C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059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06D236-277F-48E2-A160-8E8D67DE90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FDBD013-FE8F-43D0-B64E-04FB0EE021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AF1854-C218-40A0-8912-1A5E858DE5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12FF69-F540-41BA-83FA-84DBE10E9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2FA2D8-D4AD-4A10-B080-BE45A3C7E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E73FF3-9436-46D2-8104-D305148B1A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317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C793803-7F62-4687-BB23-2AFFB4F34F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7427C9-94FA-4E85-BB5C-88A49FB7A2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91DC6F-42CB-4889-9AD1-00DFCE7CB4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A3D59A-249E-49C1-950C-A108B1FA5C3F}" type="datetimeFigureOut">
              <a:rPr lang="en-US" smtClean="0"/>
              <a:t>9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385165-5FDF-40CC-A8A0-491CF7A5BA4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369D5-281F-4FE0-98FE-D0F6FC05E1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B359C5-0F49-4793-9E70-17B538064A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059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w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4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18A9BC86-92FB-4DEF-973B-BF389ED54B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6374121"/>
              </p:ext>
            </p:extLst>
          </p:nvPr>
        </p:nvGraphicFramePr>
        <p:xfrm>
          <a:off x="868222" y="1752436"/>
          <a:ext cx="2789808" cy="29354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0" r:id="rId3" imgW="1700640" imgH="1788840" progId="">
                  <p:embed/>
                </p:oleObj>
              </mc:Choice>
              <mc:Fallback>
                <p:oleObj r:id="rId3" imgW="1700640" imgH="17888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68222" y="1752436"/>
                        <a:ext cx="2789808" cy="29354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168ABA2-65D2-4BA9-8094-B02104B75DDB}"/>
              </a:ext>
            </a:extLst>
          </p:cNvPr>
          <p:cNvSpPr txBox="1"/>
          <p:nvPr/>
        </p:nvSpPr>
        <p:spPr>
          <a:xfrm>
            <a:off x="405305" y="172655"/>
            <a:ext cx="6607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PI3K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1311788A-9351-45DA-B0C8-7D7CB50422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8532645"/>
              </p:ext>
            </p:extLst>
          </p:nvPr>
        </p:nvGraphicFramePr>
        <p:xfrm>
          <a:off x="4746709" y="1746310"/>
          <a:ext cx="2711450" cy="29990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1" r:id="rId5" imgW="1615320" imgH="1645920" progId="">
                  <p:embed/>
                </p:oleObj>
              </mc:Choice>
              <mc:Fallback>
                <p:oleObj r:id="rId5" imgW="1615320" imgH="16459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46709" y="1746310"/>
                        <a:ext cx="2711450" cy="29990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C9BEEC1F-BC72-4C43-A3DD-1D560864661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32823570"/>
              </p:ext>
            </p:extLst>
          </p:nvPr>
        </p:nvGraphicFramePr>
        <p:xfrm>
          <a:off x="8323819" y="1734169"/>
          <a:ext cx="2711450" cy="2905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2" r:id="rId7" imgW="1694520" imgH="1816560" progId="">
                  <p:embed/>
                </p:oleObj>
              </mc:Choice>
              <mc:Fallback>
                <p:oleObj r:id="rId7" imgW="1694520" imgH="18165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323819" y="1734169"/>
                        <a:ext cx="2711450" cy="2905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A3966280-55DA-4760-90B7-8093A6022D51}"/>
              </a:ext>
            </a:extLst>
          </p:cNvPr>
          <p:cNvSpPr txBox="1"/>
          <p:nvPr/>
        </p:nvSpPr>
        <p:spPr>
          <a:xfrm>
            <a:off x="605073" y="1925628"/>
            <a:ext cx="574495" cy="2446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dirty="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D68B7B2E-C541-42D0-8B4B-22048A554D77}"/>
              </a:ext>
            </a:extLst>
          </p:cNvPr>
          <p:cNvCxnSpPr>
            <a:cxnSpLocks/>
          </p:cNvCxnSpPr>
          <p:nvPr/>
        </p:nvCxnSpPr>
        <p:spPr>
          <a:xfrm flipH="1" flipV="1">
            <a:off x="3577856" y="2553416"/>
            <a:ext cx="133708" cy="25556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67E9F9C0-925A-4162-BF78-21D8572D0419}"/>
              </a:ext>
            </a:extLst>
          </p:cNvPr>
          <p:cNvSpPr txBox="1"/>
          <p:nvPr/>
        </p:nvSpPr>
        <p:spPr>
          <a:xfrm>
            <a:off x="3394368" y="2856653"/>
            <a:ext cx="6543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-PI3K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EC903AD-A2C4-4131-95A9-7211CF2A156D}"/>
              </a:ext>
            </a:extLst>
          </p:cNvPr>
          <p:cNvCxnSpPr>
            <a:cxnSpLocks/>
          </p:cNvCxnSpPr>
          <p:nvPr/>
        </p:nvCxnSpPr>
        <p:spPr>
          <a:xfrm flipH="1" flipV="1">
            <a:off x="7278723" y="2659003"/>
            <a:ext cx="209580" cy="3712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AA819E77-D108-4482-B306-E6D08DCDF4DE}"/>
              </a:ext>
            </a:extLst>
          </p:cNvPr>
          <p:cNvSpPr txBox="1"/>
          <p:nvPr/>
        </p:nvSpPr>
        <p:spPr>
          <a:xfrm>
            <a:off x="7115444" y="3083126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t-PI3K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37FCDD3D-BC26-4C59-83EF-ACC074C20948}"/>
              </a:ext>
            </a:extLst>
          </p:cNvPr>
          <p:cNvCxnSpPr>
            <a:cxnSpLocks/>
          </p:cNvCxnSpPr>
          <p:nvPr/>
        </p:nvCxnSpPr>
        <p:spPr>
          <a:xfrm flipH="1" flipV="1">
            <a:off x="10954520" y="3201253"/>
            <a:ext cx="133709" cy="29373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475EF6F8-2F5C-4DBB-9294-301F5E244962}"/>
              </a:ext>
            </a:extLst>
          </p:cNvPr>
          <p:cNvSpPr txBox="1"/>
          <p:nvPr/>
        </p:nvSpPr>
        <p:spPr>
          <a:xfrm>
            <a:off x="10812952" y="3560451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dirty="0"/>
              <a:t>β</a:t>
            </a:r>
            <a:r>
              <a:rPr lang="en-US" sz="1400" dirty="0"/>
              <a:t>-Actin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2685F87E-8862-420C-9311-F182B5377D55}"/>
              </a:ext>
            </a:extLst>
          </p:cNvPr>
          <p:cNvSpPr/>
          <p:nvPr/>
        </p:nvSpPr>
        <p:spPr>
          <a:xfrm>
            <a:off x="1375883" y="203433"/>
            <a:ext cx="233568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nformation for Ladder:</a:t>
            </a:r>
          </a:p>
          <a:p>
            <a:r>
              <a:rPr lang="en-US" sz="1400" dirty="0"/>
              <a:t>Company: Fisher Scientific</a:t>
            </a:r>
          </a:p>
          <a:p>
            <a:r>
              <a:rPr lang="en-US" sz="1400" dirty="0"/>
              <a:t>Cat. #: 1063839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BA2EBFE-E91B-4F54-8F25-28E0A4CD04A3}"/>
              </a:ext>
            </a:extLst>
          </p:cNvPr>
          <p:cNvSpPr txBox="1"/>
          <p:nvPr/>
        </p:nvSpPr>
        <p:spPr>
          <a:xfrm>
            <a:off x="4459461" y="2124710"/>
            <a:ext cx="574495" cy="24468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EA61713-367D-4C8A-A3C5-32EBEEDF6C0C}"/>
              </a:ext>
            </a:extLst>
          </p:cNvPr>
          <p:cNvSpPr txBox="1"/>
          <p:nvPr/>
        </p:nvSpPr>
        <p:spPr>
          <a:xfrm>
            <a:off x="8028895" y="1787129"/>
            <a:ext cx="574495" cy="27238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043FDD7-51E0-44EC-BA7C-BDF3F4D2B642}"/>
              </a:ext>
            </a:extLst>
          </p:cNvPr>
          <p:cNvSpPr txBox="1"/>
          <p:nvPr/>
        </p:nvSpPr>
        <p:spPr>
          <a:xfrm>
            <a:off x="536911" y="1426392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E4283EB-8CC0-41F0-8744-81AD7E2BC052}"/>
              </a:ext>
            </a:extLst>
          </p:cNvPr>
          <p:cNvSpPr txBox="1"/>
          <p:nvPr/>
        </p:nvSpPr>
        <p:spPr>
          <a:xfrm>
            <a:off x="4187413" y="1501095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FACDA38-542C-4F94-A37D-B4AB7594C46A}"/>
              </a:ext>
            </a:extLst>
          </p:cNvPr>
          <p:cNvSpPr txBox="1"/>
          <p:nvPr/>
        </p:nvSpPr>
        <p:spPr>
          <a:xfrm>
            <a:off x="7967927" y="1347206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</p:spTree>
    <p:extLst>
      <p:ext uri="{BB962C8B-B14F-4D97-AF65-F5344CB8AC3E}">
        <p14:creationId xmlns:p14="http://schemas.microsoft.com/office/powerpoint/2010/main" val="6851340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7D69FA1-FA9D-4C08-A842-2277E39D5647}"/>
              </a:ext>
            </a:extLst>
          </p:cNvPr>
          <p:cNvSpPr txBox="1"/>
          <p:nvPr/>
        </p:nvSpPr>
        <p:spPr>
          <a:xfrm>
            <a:off x="387566" y="216803"/>
            <a:ext cx="6078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AKT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26B7064C-CDAD-4E5F-98E0-BCACCDA058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0944331"/>
              </p:ext>
            </p:extLst>
          </p:nvPr>
        </p:nvGraphicFramePr>
        <p:xfrm>
          <a:off x="1548329" y="1485393"/>
          <a:ext cx="2549529" cy="3501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5" r:id="rId3" imgW="1121400" imgH="1981080" progId="">
                  <p:embed/>
                </p:oleObj>
              </mc:Choice>
              <mc:Fallback>
                <p:oleObj r:id="rId3" imgW="1121400" imgH="19810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48329" y="1485393"/>
                        <a:ext cx="2549529" cy="3501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F430E79D-B3AF-492C-A103-0B84643F12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5563969"/>
              </p:ext>
            </p:extLst>
          </p:nvPr>
        </p:nvGraphicFramePr>
        <p:xfrm>
          <a:off x="5016694" y="1394529"/>
          <a:ext cx="2719329" cy="3501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6" r:id="rId5" imgW="1670040" imgH="1938240" progId="">
                  <p:embed/>
                </p:oleObj>
              </mc:Choice>
              <mc:Fallback>
                <p:oleObj r:id="rId5" imgW="1670040" imgH="193824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016694" y="1394529"/>
                        <a:ext cx="2719329" cy="3501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9B9E75E2-F9E5-4513-A0DB-05493FE16F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2879244"/>
              </p:ext>
            </p:extLst>
          </p:nvPr>
        </p:nvGraphicFramePr>
        <p:xfrm>
          <a:off x="8612039" y="1485393"/>
          <a:ext cx="2455651" cy="33083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7" r:id="rId7" imgW="1709640" imgH="1834560" progId="">
                  <p:embed/>
                </p:oleObj>
              </mc:Choice>
              <mc:Fallback>
                <p:oleObj r:id="rId7" imgW="1709640" imgH="183456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612039" y="1485393"/>
                        <a:ext cx="2455651" cy="33083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51FCA3A9-BA2E-44E9-B325-69D51B6D11CB}"/>
              </a:ext>
            </a:extLst>
          </p:cNvPr>
          <p:cNvSpPr txBox="1"/>
          <p:nvPr/>
        </p:nvSpPr>
        <p:spPr>
          <a:xfrm>
            <a:off x="1192939" y="1556061"/>
            <a:ext cx="357790" cy="34163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  <a:p>
            <a:endParaRPr lang="en-US" sz="900" dirty="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9EDEC35A-F8F5-4CB0-8EB8-A416C3BB0F55}"/>
              </a:ext>
            </a:extLst>
          </p:cNvPr>
          <p:cNvCxnSpPr>
            <a:cxnSpLocks/>
          </p:cNvCxnSpPr>
          <p:nvPr/>
        </p:nvCxnSpPr>
        <p:spPr>
          <a:xfrm flipH="1" flipV="1">
            <a:off x="3964149" y="2704022"/>
            <a:ext cx="133709" cy="31083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D51A0887-1065-415F-A7C4-67DD5B221F53}"/>
              </a:ext>
            </a:extLst>
          </p:cNvPr>
          <p:cNvCxnSpPr>
            <a:cxnSpLocks/>
          </p:cNvCxnSpPr>
          <p:nvPr/>
        </p:nvCxnSpPr>
        <p:spPr>
          <a:xfrm flipH="1" flipV="1">
            <a:off x="7557405" y="2621399"/>
            <a:ext cx="101136" cy="31069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77DBDF76-B5F6-49A7-9438-364F223B4053}"/>
              </a:ext>
            </a:extLst>
          </p:cNvPr>
          <p:cNvSpPr txBox="1"/>
          <p:nvPr/>
        </p:nvSpPr>
        <p:spPr>
          <a:xfrm>
            <a:off x="3806291" y="3110332"/>
            <a:ext cx="6303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-AK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79A4E1A-2E7C-4878-8E00-3DDAE65B9B26}"/>
              </a:ext>
            </a:extLst>
          </p:cNvPr>
          <p:cNvSpPr txBox="1"/>
          <p:nvPr/>
        </p:nvSpPr>
        <p:spPr>
          <a:xfrm>
            <a:off x="7382785" y="3121223"/>
            <a:ext cx="5966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-AK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DEE2F1F-F5C3-42A8-9B68-875BA99D3088}"/>
              </a:ext>
            </a:extLst>
          </p:cNvPr>
          <p:cNvSpPr txBox="1"/>
          <p:nvPr/>
        </p:nvSpPr>
        <p:spPr>
          <a:xfrm>
            <a:off x="10769664" y="3555191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b="1" dirty="0"/>
              <a:t>β</a:t>
            </a:r>
            <a:r>
              <a:rPr lang="en-US" sz="1400" b="1" dirty="0"/>
              <a:t>-Actin</a:t>
            </a:r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18C72E54-4932-4521-9063-E4E1D6E195D0}"/>
              </a:ext>
            </a:extLst>
          </p:cNvPr>
          <p:cNvCxnSpPr>
            <a:cxnSpLocks/>
          </p:cNvCxnSpPr>
          <p:nvPr/>
        </p:nvCxnSpPr>
        <p:spPr>
          <a:xfrm flipH="1" flipV="1">
            <a:off x="10987975" y="3162769"/>
            <a:ext cx="79715" cy="2800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>
            <a:extLst>
              <a:ext uri="{FF2B5EF4-FFF2-40B4-BE49-F238E27FC236}">
                <a16:creationId xmlns:a16="http://schemas.microsoft.com/office/drawing/2014/main" id="{A273E036-2611-4CAA-9BF1-1CFFFAD12E5F}"/>
              </a:ext>
            </a:extLst>
          </p:cNvPr>
          <p:cNvSpPr/>
          <p:nvPr/>
        </p:nvSpPr>
        <p:spPr>
          <a:xfrm>
            <a:off x="1237066" y="216803"/>
            <a:ext cx="233568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nformation for Ladder:</a:t>
            </a:r>
          </a:p>
          <a:p>
            <a:r>
              <a:rPr lang="en-US" sz="1400" dirty="0"/>
              <a:t>Company: Fisher Scientific</a:t>
            </a:r>
          </a:p>
          <a:p>
            <a:r>
              <a:rPr lang="en-US" sz="1400" dirty="0"/>
              <a:t>Cat. #: 1063839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AC107FF-5A9F-4FAC-8589-D1D7A6818C7E}"/>
              </a:ext>
            </a:extLst>
          </p:cNvPr>
          <p:cNvSpPr txBox="1"/>
          <p:nvPr/>
        </p:nvSpPr>
        <p:spPr>
          <a:xfrm>
            <a:off x="1237066" y="1159257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F6EB7A1-8BEE-4E01-8289-7BCD9B0FA355}"/>
              </a:ext>
            </a:extLst>
          </p:cNvPr>
          <p:cNvSpPr txBox="1"/>
          <p:nvPr/>
        </p:nvSpPr>
        <p:spPr>
          <a:xfrm>
            <a:off x="4751020" y="1519693"/>
            <a:ext cx="357790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  <a:p>
            <a:endParaRPr lang="en-US" sz="9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00F3B38-5E2F-44E8-B9AA-FD18C1FB73D0}"/>
              </a:ext>
            </a:extLst>
          </p:cNvPr>
          <p:cNvSpPr txBox="1"/>
          <p:nvPr/>
        </p:nvSpPr>
        <p:spPr>
          <a:xfrm>
            <a:off x="4579658" y="1086752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6DEAA6B-0D84-42A2-B426-70B513FCA9E5}"/>
              </a:ext>
            </a:extLst>
          </p:cNvPr>
          <p:cNvSpPr txBox="1"/>
          <p:nvPr/>
        </p:nvSpPr>
        <p:spPr>
          <a:xfrm>
            <a:off x="8429245" y="957605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9ADA759-CB56-4D95-BD09-42AB8DF23C92}"/>
              </a:ext>
            </a:extLst>
          </p:cNvPr>
          <p:cNvSpPr txBox="1"/>
          <p:nvPr/>
        </p:nvSpPr>
        <p:spPr>
          <a:xfrm>
            <a:off x="8160398" y="1556061"/>
            <a:ext cx="483234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  <a:p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6762182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4C8AE45-B816-4DFC-AE00-EAC6B3A7B0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94303" y="1634448"/>
            <a:ext cx="2539036" cy="314184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BAC3A98-B11E-4132-9A08-EBEFB49B85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4015" y="1594220"/>
            <a:ext cx="2846790" cy="322230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EDE0D0F-5FD2-4067-90E3-24C29EE63AFF}"/>
              </a:ext>
            </a:extLst>
          </p:cNvPr>
          <p:cNvSpPr txBox="1"/>
          <p:nvPr/>
        </p:nvSpPr>
        <p:spPr>
          <a:xfrm>
            <a:off x="806764" y="1813173"/>
            <a:ext cx="357790" cy="27238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  <a:p>
            <a:endParaRPr lang="en-US" sz="900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90AA601-D829-4C8A-B833-B949E7D071C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66948" y="1594220"/>
            <a:ext cx="2627377" cy="322538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F7B85CA-9085-4C8B-8635-9FC282F3471B}"/>
              </a:ext>
            </a:extLst>
          </p:cNvPr>
          <p:cNvSpPr txBox="1"/>
          <p:nvPr/>
        </p:nvSpPr>
        <p:spPr>
          <a:xfrm>
            <a:off x="611718" y="91177"/>
            <a:ext cx="5774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P38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BE489F6-5822-41E8-B3CA-A9006E145903}"/>
              </a:ext>
            </a:extLst>
          </p:cNvPr>
          <p:cNvCxnSpPr>
            <a:cxnSpLocks/>
          </p:cNvCxnSpPr>
          <p:nvPr/>
        </p:nvCxnSpPr>
        <p:spPr>
          <a:xfrm flipH="1" flipV="1">
            <a:off x="3788868" y="2961899"/>
            <a:ext cx="74812" cy="3414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CE12243E-0A73-4897-BE17-209ED69AC688}"/>
              </a:ext>
            </a:extLst>
          </p:cNvPr>
          <p:cNvSpPr txBox="1"/>
          <p:nvPr/>
        </p:nvSpPr>
        <p:spPr>
          <a:xfrm>
            <a:off x="3519139" y="3390759"/>
            <a:ext cx="6142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P-p38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C888832-8F9B-40D8-83B4-66C34DEEAB19}"/>
              </a:ext>
            </a:extLst>
          </p:cNvPr>
          <p:cNvCxnSpPr>
            <a:cxnSpLocks/>
          </p:cNvCxnSpPr>
          <p:nvPr/>
        </p:nvCxnSpPr>
        <p:spPr>
          <a:xfrm flipH="1" flipV="1">
            <a:off x="7443741" y="3251614"/>
            <a:ext cx="89478" cy="3204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414B353-0E1C-4086-99CC-7559D9C2C0CA}"/>
              </a:ext>
            </a:extLst>
          </p:cNvPr>
          <p:cNvSpPr txBox="1"/>
          <p:nvPr/>
        </p:nvSpPr>
        <p:spPr>
          <a:xfrm>
            <a:off x="7266912" y="3541863"/>
            <a:ext cx="5774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t-p38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15BF5262-55A1-4484-AC19-06A9F16F3E1F}"/>
              </a:ext>
            </a:extLst>
          </p:cNvPr>
          <p:cNvCxnSpPr>
            <a:cxnSpLocks/>
          </p:cNvCxnSpPr>
          <p:nvPr/>
        </p:nvCxnSpPr>
        <p:spPr>
          <a:xfrm flipH="1" flipV="1">
            <a:off x="10684727" y="3474106"/>
            <a:ext cx="48612" cy="28688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097B7C05-796F-491E-8656-A769ACF8B96C}"/>
              </a:ext>
            </a:extLst>
          </p:cNvPr>
          <p:cNvSpPr txBox="1"/>
          <p:nvPr/>
        </p:nvSpPr>
        <p:spPr>
          <a:xfrm>
            <a:off x="10373107" y="3784804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b="1" dirty="0"/>
              <a:t>β</a:t>
            </a:r>
            <a:r>
              <a:rPr lang="en-US" sz="1400" b="1" dirty="0"/>
              <a:t>-Actin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139C71E-07FD-416C-A721-E01A18B03102}"/>
              </a:ext>
            </a:extLst>
          </p:cNvPr>
          <p:cNvSpPr/>
          <p:nvPr/>
        </p:nvSpPr>
        <p:spPr>
          <a:xfrm>
            <a:off x="1996586" y="172748"/>
            <a:ext cx="233568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nformation for Ladder:</a:t>
            </a:r>
          </a:p>
          <a:p>
            <a:r>
              <a:rPr lang="en-US" sz="1400" dirty="0"/>
              <a:t>Company: Fisher Scientific</a:t>
            </a:r>
          </a:p>
          <a:p>
            <a:r>
              <a:rPr lang="en-US" sz="1400" dirty="0"/>
              <a:t>Cat. #: 1063839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71FF7BB-EF11-49BA-BB14-DF11ECD1E7AA}"/>
              </a:ext>
            </a:extLst>
          </p:cNvPr>
          <p:cNvSpPr txBox="1"/>
          <p:nvPr/>
        </p:nvSpPr>
        <p:spPr>
          <a:xfrm>
            <a:off x="806764" y="1225870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952281A-771F-42F8-8FCE-FA42FC0F630D}"/>
              </a:ext>
            </a:extLst>
          </p:cNvPr>
          <p:cNvSpPr txBox="1"/>
          <p:nvPr/>
        </p:nvSpPr>
        <p:spPr>
          <a:xfrm>
            <a:off x="4674343" y="1294969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1431650-9655-4BDA-8B99-26688D60E9A0}"/>
              </a:ext>
            </a:extLst>
          </p:cNvPr>
          <p:cNvSpPr txBox="1"/>
          <p:nvPr/>
        </p:nvSpPr>
        <p:spPr>
          <a:xfrm>
            <a:off x="8194303" y="1223379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8B3647C-75D5-417B-B8D2-DBE2DD71EEC4}"/>
              </a:ext>
            </a:extLst>
          </p:cNvPr>
          <p:cNvSpPr txBox="1"/>
          <p:nvPr/>
        </p:nvSpPr>
        <p:spPr>
          <a:xfrm>
            <a:off x="4688053" y="1770689"/>
            <a:ext cx="357790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</a:p>
          <a:p>
            <a:endParaRPr lang="en-US" sz="9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4531AFE-DDEA-45FB-BC12-4EB5158A65D1}"/>
              </a:ext>
            </a:extLst>
          </p:cNvPr>
          <p:cNvSpPr txBox="1"/>
          <p:nvPr/>
        </p:nvSpPr>
        <p:spPr>
          <a:xfrm>
            <a:off x="8125214" y="2155763"/>
            <a:ext cx="357790" cy="30008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0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</a:t>
            </a: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2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3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4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9771046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A6B3409-14F7-4712-94F8-2C3FDF99FA3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37255" y="1519033"/>
            <a:ext cx="2919844" cy="437553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1CC278F-72CD-4DDD-8683-4763EBD38CDF}"/>
              </a:ext>
            </a:extLst>
          </p:cNvPr>
          <p:cNvSpPr txBox="1"/>
          <p:nvPr/>
        </p:nvSpPr>
        <p:spPr>
          <a:xfrm>
            <a:off x="1147642" y="522481"/>
            <a:ext cx="19260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ytochrome 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EA5DA6E-995E-4139-9E98-ABF46BEA112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64395" y="2010270"/>
            <a:ext cx="2849144" cy="341947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BCC10B9-0E03-45F0-BB78-ADCD671AFF13}"/>
              </a:ext>
            </a:extLst>
          </p:cNvPr>
          <p:cNvSpPr txBox="1"/>
          <p:nvPr/>
        </p:nvSpPr>
        <p:spPr>
          <a:xfrm>
            <a:off x="1320750" y="1107733"/>
            <a:ext cx="2228302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Information for Ladder:</a:t>
            </a:r>
          </a:p>
          <a:p>
            <a:r>
              <a:rPr lang="en-US" sz="1400" dirty="0"/>
              <a:t>Company: Thermo Scientific</a:t>
            </a:r>
          </a:p>
          <a:p>
            <a:r>
              <a:rPr lang="en-US" sz="1400" dirty="0"/>
              <a:t>Cat. #: 26620</a:t>
            </a:r>
          </a:p>
          <a:p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E7664A2-61AC-4070-96D1-4D444AB1496C}"/>
              </a:ext>
            </a:extLst>
          </p:cNvPr>
          <p:cNvSpPr txBox="1"/>
          <p:nvPr/>
        </p:nvSpPr>
        <p:spPr>
          <a:xfrm>
            <a:off x="5536421" y="2828192"/>
            <a:ext cx="407484" cy="20928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35</a:t>
            </a:r>
          </a:p>
          <a:p>
            <a:endParaRPr lang="en-US" sz="1400" b="1" dirty="0"/>
          </a:p>
          <a:p>
            <a:endParaRPr lang="en-US" sz="1400" b="1" dirty="0"/>
          </a:p>
          <a:p>
            <a:endParaRPr lang="en-US" sz="1400" b="1" dirty="0"/>
          </a:p>
          <a:p>
            <a:r>
              <a:rPr lang="en-US" sz="1400" b="1" dirty="0"/>
              <a:t>25 </a:t>
            </a:r>
          </a:p>
          <a:p>
            <a:endParaRPr lang="en-US" sz="1400" b="1" dirty="0"/>
          </a:p>
          <a:p>
            <a:endParaRPr lang="en-US" sz="1400" b="1" dirty="0"/>
          </a:p>
          <a:p>
            <a:r>
              <a:rPr lang="en-US" sz="1400" b="1" dirty="0"/>
              <a:t>15</a:t>
            </a:r>
          </a:p>
          <a:p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DDEFC9-69DF-4987-8AB2-A859AE58D979}"/>
              </a:ext>
            </a:extLst>
          </p:cNvPr>
          <p:cNvSpPr txBox="1"/>
          <p:nvPr/>
        </p:nvSpPr>
        <p:spPr>
          <a:xfrm>
            <a:off x="4825594" y="1615564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F22D3EA-6953-466C-BABE-E30077FAE6FF}"/>
              </a:ext>
            </a:extLst>
          </p:cNvPr>
          <p:cNvSpPr txBox="1"/>
          <p:nvPr/>
        </p:nvSpPr>
        <p:spPr>
          <a:xfrm>
            <a:off x="9131353" y="1107733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99BD6756-0545-46EB-BE26-96875C4B3D9C}"/>
              </a:ext>
            </a:extLst>
          </p:cNvPr>
          <p:cNvCxnSpPr>
            <a:cxnSpLocks/>
          </p:cNvCxnSpPr>
          <p:nvPr/>
        </p:nvCxnSpPr>
        <p:spPr>
          <a:xfrm flipH="1">
            <a:off x="5326552" y="4481474"/>
            <a:ext cx="28698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7A3D8545-0BCF-45E2-8F4E-7B7683A4A035}"/>
              </a:ext>
            </a:extLst>
          </p:cNvPr>
          <p:cNvSpPr txBox="1"/>
          <p:nvPr/>
        </p:nvSpPr>
        <p:spPr>
          <a:xfrm>
            <a:off x="5356822" y="4613296"/>
            <a:ext cx="12220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ytochrome C</a:t>
            </a:r>
          </a:p>
        </p:txBody>
      </p:sp>
    </p:spTree>
    <p:extLst>
      <p:ext uri="{BB962C8B-B14F-4D97-AF65-F5344CB8AC3E}">
        <p14:creationId xmlns:p14="http://schemas.microsoft.com/office/powerpoint/2010/main" val="1570693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7EBDBB7-0A13-400B-98C5-3010CF069FE1}"/>
              </a:ext>
            </a:extLst>
          </p:cNvPr>
          <p:cNvSpPr txBox="1"/>
          <p:nvPr/>
        </p:nvSpPr>
        <p:spPr>
          <a:xfrm>
            <a:off x="576722" y="440098"/>
            <a:ext cx="12554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Caspase-3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07CCF0B-429F-475D-A334-0E4D6D444A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61471" y="1764964"/>
            <a:ext cx="3331924" cy="437142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F5D2D67-310C-40E8-B2D1-0032A2AC74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77984" y="2129169"/>
            <a:ext cx="3141730" cy="3703147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D1E0FA6F-EB8C-4CA0-B293-7CE275331C64}"/>
              </a:ext>
            </a:extLst>
          </p:cNvPr>
          <p:cNvSpPr/>
          <p:nvPr/>
        </p:nvSpPr>
        <p:spPr>
          <a:xfrm>
            <a:off x="484636" y="840208"/>
            <a:ext cx="233568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nformation for Ladder:</a:t>
            </a:r>
          </a:p>
          <a:p>
            <a:r>
              <a:rPr lang="en-US" sz="1400" dirty="0"/>
              <a:t>Company: Thermo Scientific</a:t>
            </a:r>
          </a:p>
          <a:p>
            <a:r>
              <a:rPr lang="en-US" sz="1400" dirty="0"/>
              <a:t>Cat. #: 266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DC7AD6B-F68B-4AEB-85E8-FC6591F286F2}"/>
              </a:ext>
            </a:extLst>
          </p:cNvPr>
          <p:cNvSpPr txBox="1"/>
          <p:nvPr/>
        </p:nvSpPr>
        <p:spPr>
          <a:xfrm>
            <a:off x="2912876" y="1420732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30C0662-0E16-423A-95EE-4D929F864C93}"/>
              </a:ext>
            </a:extLst>
          </p:cNvPr>
          <p:cNvSpPr txBox="1"/>
          <p:nvPr/>
        </p:nvSpPr>
        <p:spPr>
          <a:xfrm>
            <a:off x="7215106" y="1684873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6317A17-BA93-48B4-9400-148BFA2D6B76}"/>
              </a:ext>
            </a:extLst>
          </p:cNvPr>
          <p:cNvSpPr txBox="1"/>
          <p:nvPr/>
        </p:nvSpPr>
        <p:spPr>
          <a:xfrm>
            <a:off x="2884212" y="461934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1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B67B63B-EEE0-4E17-8F5A-05D8BBC0CEDF}"/>
              </a:ext>
            </a:extLst>
          </p:cNvPr>
          <p:cNvSpPr txBox="1"/>
          <p:nvPr/>
        </p:nvSpPr>
        <p:spPr>
          <a:xfrm>
            <a:off x="2884212" y="367296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2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F47A5FC-E593-4386-AC45-8AB3D5F29DD3}"/>
              </a:ext>
            </a:extLst>
          </p:cNvPr>
          <p:cNvSpPr txBox="1"/>
          <p:nvPr/>
        </p:nvSpPr>
        <p:spPr>
          <a:xfrm>
            <a:off x="2894063" y="316058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3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922AA56-ED0A-4816-9FE3-FF3FF0337E50}"/>
              </a:ext>
            </a:extLst>
          </p:cNvPr>
          <p:cNvSpPr txBox="1"/>
          <p:nvPr/>
        </p:nvSpPr>
        <p:spPr>
          <a:xfrm>
            <a:off x="2894063" y="284252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5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DF615BC-FBB0-43C6-BB89-E1BCAB532E38}"/>
              </a:ext>
            </a:extLst>
          </p:cNvPr>
          <p:cNvSpPr txBox="1"/>
          <p:nvPr/>
        </p:nvSpPr>
        <p:spPr>
          <a:xfrm>
            <a:off x="2884212" y="2433246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7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0CFFFF8-C777-452A-8565-8082C9B02565}"/>
              </a:ext>
            </a:extLst>
          </p:cNvPr>
          <p:cNvSpPr txBox="1"/>
          <p:nvPr/>
        </p:nvSpPr>
        <p:spPr>
          <a:xfrm>
            <a:off x="2880564" y="2148074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1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6BAAB4D-EBC9-4F70-9AF0-06CC29DDAD95}"/>
              </a:ext>
            </a:extLst>
          </p:cNvPr>
          <p:cNvSpPr txBox="1"/>
          <p:nvPr/>
        </p:nvSpPr>
        <p:spPr>
          <a:xfrm>
            <a:off x="6257575" y="4916201"/>
            <a:ext cx="9252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Caspase-3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0F7F072B-C2B6-4284-B82A-495306F5432F}"/>
              </a:ext>
            </a:extLst>
          </p:cNvPr>
          <p:cNvCxnSpPr>
            <a:cxnSpLocks/>
            <a:stCxn id="22" idx="0"/>
          </p:cNvCxnSpPr>
          <p:nvPr/>
        </p:nvCxnSpPr>
        <p:spPr>
          <a:xfrm flipH="1" flipV="1">
            <a:off x="6346144" y="4619341"/>
            <a:ext cx="374058" cy="2968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0B1C5A76-830D-4B6C-B01E-80F20E79A62F}"/>
              </a:ext>
            </a:extLst>
          </p:cNvPr>
          <p:cNvSpPr txBox="1"/>
          <p:nvPr/>
        </p:nvSpPr>
        <p:spPr>
          <a:xfrm>
            <a:off x="11026212" y="4250008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b="1" dirty="0"/>
              <a:t>β</a:t>
            </a:r>
            <a:r>
              <a:rPr lang="en-US" sz="1400" b="1" dirty="0"/>
              <a:t>-Actin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B7D147D6-BC4A-490C-88F6-EEE4D5FCED72}"/>
              </a:ext>
            </a:extLst>
          </p:cNvPr>
          <p:cNvCxnSpPr>
            <a:cxnSpLocks/>
          </p:cNvCxnSpPr>
          <p:nvPr/>
        </p:nvCxnSpPr>
        <p:spPr>
          <a:xfrm flipH="1" flipV="1">
            <a:off x="10704328" y="4101578"/>
            <a:ext cx="374058" cy="2968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1F8A61E-3BB8-4CB7-BE08-C90901247ED9}"/>
              </a:ext>
            </a:extLst>
          </p:cNvPr>
          <p:cNvSpPr txBox="1"/>
          <p:nvPr/>
        </p:nvSpPr>
        <p:spPr>
          <a:xfrm>
            <a:off x="7310576" y="3698511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55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0522921-241D-4BFD-AB1B-4EFB2846EA41}"/>
              </a:ext>
            </a:extLst>
          </p:cNvPr>
          <p:cNvSpPr txBox="1"/>
          <p:nvPr/>
        </p:nvSpPr>
        <p:spPr>
          <a:xfrm>
            <a:off x="7310576" y="443467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35</a:t>
            </a:r>
          </a:p>
        </p:txBody>
      </p:sp>
    </p:spTree>
    <p:extLst>
      <p:ext uri="{BB962C8B-B14F-4D97-AF65-F5344CB8AC3E}">
        <p14:creationId xmlns:p14="http://schemas.microsoft.com/office/powerpoint/2010/main" val="3163726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DC8B287-AF7A-4E0F-80F4-D4B842A6CE3D}"/>
              </a:ext>
            </a:extLst>
          </p:cNvPr>
          <p:cNvSpPr txBox="1"/>
          <p:nvPr/>
        </p:nvSpPr>
        <p:spPr>
          <a:xfrm flipH="1">
            <a:off x="795032" y="233017"/>
            <a:ext cx="7073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BAX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E46E571-5E2C-4531-B7C7-EF21A2131B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3731" y="1799466"/>
            <a:ext cx="3447619" cy="446666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55E13B25-36AC-479D-9F7D-8CEA150CB0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84241" y="1856609"/>
            <a:ext cx="3028571" cy="4409524"/>
          </a:xfrm>
          <a:prstGeom prst="rect">
            <a:avLst/>
          </a:prstGeom>
        </p:spPr>
      </p:pic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31890989-AB92-4D1D-8D63-D6BC3EFDF05E}"/>
              </a:ext>
            </a:extLst>
          </p:cNvPr>
          <p:cNvCxnSpPr/>
          <p:nvPr/>
        </p:nvCxnSpPr>
        <p:spPr>
          <a:xfrm flipH="1">
            <a:off x="9898663" y="3757437"/>
            <a:ext cx="267419" cy="1552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CB68D334-E7E8-45F8-BDE0-86FF2D9E215D}"/>
              </a:ext>
            </a:extLst>
          </p:cNvPr>
          <p:cNvSpPr txBox="1"/>
          <p:nvPr/>
        </p:nvSpPr>
        <p:spPr>
          <a:xfrm>
            <a:off x="10176457" y="3572771"/>
            <a:ext cx="8611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n-US" dirty="0"/>
              <a:t>-Actin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50DE049-0502-41E6-BD58-98229360EF8B}"/>
              </a:ext>
            </a:extLst>
          </p:cNvPr>
          <p:cNvSpPr/>
          <p:nvPr/>
        </p:nvSpPr>
        <p:spPr>
          <a:xfrm>
            <a:off x="602793" y="840208"/>
            <a:ext cx="2335681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nformation for Ladder:</a:t>
            </a:r>
          </a:p>
          <a:p>
            <a:r>
              <a:rPr lang="en-US" sz="1400" dirty="0"/>
              <a:t>Company: Thermo Scientific</a:t>
            </a:r>
          </a:p>
          <a:p>
            <a:r>
              <a:rPr lang="en-US" sz="1400" dirty="0"/>
              <a:t>Cat. #: 266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70F1B8D-AE12-4843-B035-779A88BFB0BC}"/>
              </a:ext>
            </a:extLst>
          </p:cNvPr>
          <p:cNvSpPr txBox="1"/>
          <p:nvPr/>
        </p:nvSpPr>
        <p:spPr>
          <a:xfrm>
            <a:off x="6662996" y="419678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3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3DF631E-D2A1-41D1-8EB5-5059B6CE176F}"/>
              </a:ext>
            </a:extLst>
          </p:cNvPr>
          <p:cNvSpPr txBox="1"/>
          <p:nvPr/>
        </p:nvSpPr>
        <p:spPr>
          <a:xfrm>
            <a:off x="6646560" y="345858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5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FAFD060-6986-449D-8B44-FA62BB0F62C5}"/>
              </a:ext>
            </a:extLst>
          </p:cNvPr>
          <p:cNvSpPr txBox="1"/>
          <p:nvPr/>
        </p:nvSpPr>
        <p:spPr>
          <a:xfrm>
            <a:off x="6671147" y="30281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7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0B77234-5B50-4F18-8509-38596FD4BA57}"/>
              </a:ext>
            </a:extLst>
          </p:cNvPr>
          <p:cNvSpPr txBox="1"/>
          <p:nvPr/>
        </p:nvSpPr>
        <p:spPr>
          <a:xfrm>
            <a:off x="6625461" y="2742985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10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F97B756-3EA4-468C-9D97-9378693AEC49}"/>
              </a:ext>
            </a:extLst>
          </p:cNvPr>
          <p:cNvSpPr txBox="1"/>
          <p:nvPr/>
        </p:nvSpPr>
        <p:spPr>
          <a:xfrm>
            <a:off x="2280698" y="1426552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C7110D7-3F05-4C6A-815A-D769C1527BA9}"/>
              </a:ext>
            </a:extLst>
          </p:cNvPr>
          <p:cNvSpPr txBox="1"/>
          <p:nvPr/>
        </p:nvSpPr>
        <p:spPr>
          <a:xfrm>
            <a:off x="6325699" y="1426184"/>
            <a:ext cx="1058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Ladder (KD)</a:t>
            </a:r>
          </a:p>
        </p:txBody>
      </p:sp>
    </p:spTree>
    <p:extLst>
      <p:ext uri="{BB962C8B-B14F-4D97-AF65-F5344CB8AC3E}">
        <p14:creationId xmlns:p14="http://schemas.microsoft.com/office/powerpoint/2010/main" val="2895341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</TotalTime>
  <Words>249</Words>
  <Application>Microsoft Office PowerPoint</Application>
  <PresentationFormat>Widescreen</PresentationFormat>
  <Paragraphs>241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he Meng</dc:creator>
  <cp:lastModifiedBy>Qinghe Meng</cp:lastModifiedBy>
  <cp:revision>32</cp:revision>
  <dcterms:created xsi:type="dcterms:W3CDTF">2022-08-10T14:53:14Z</dcterms:created>
  <dcterms:modified xsi:type="dcterms:W3CDTF">2022-09-12T16:06:58Z</dcterms:modified>
</cp:coreProperties>
</file>